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979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0E0DB7-0BB4-4D12-B9B3-9514B2BCC30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91DA55-29FE-484F-9AB1-7B033FF8E1E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54DA9F-C2CF-481D-83B9-877DD3206CD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07B9C3-3945-427F-AE3D-2B5250EDF9A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00E439-705A-4426-8AC9-8FEBB8E035C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3183D2-52E2-4D8A-BFBB-13B515911D7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2BBFEA-A470-4004-B758-5795CA5CCB0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1E6EB7-00E6-4971-8105-967DF833269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E6BAFD-E9A9-4A21-870F-BB6568C9479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241CA0-2E40-4616-ACDC-6ACDBECE63D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E966BE-C8A7-4C8F-8F0A-47EC55B746B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4ADFEC-EFAE-4500-8034-CE4C0E61422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7E6BA37-3C5F-445C-B6A9-78DA520EE12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Chart 120" descr=""/>
          <p:cNvPicPr/>
          <p:nvPr/>
        </p:nvPicPr>
        <p:blipFill>
          <a:blip r:embed="rId1"/>
          <a:stretch/>
        </p:blipFill>
        <p:spPr>
          <a:xfrm>
            <a:off x="378000" y="1073160"/>
            <a:ext cx="1616040" cy="1079640"/>
          </a:xfrm>
          <a:prstGeom prst="rect">
            <a:avLst/>
          </a:prstGeom>
          <a:ln w="0">
            <a:noFill/>
          </a:ln>
        </p:spPr>
      </p:pic>
      <p:pic>
        <p:nvPicPr>
          <p:cNvPr id="42" name="Chart 101" descr=""/>
          <p:cNvPicPr/>
          <p:nvPr/>
        </p:nvPicPr>
        <p:blipFill>
          <a:blip r:embed="rId2"/>
          <a:stretch/>
        </p:blipFill>
        <p:spPr>
          <a:xfrm>
            <a:off x="4565520" y="2968560"/>
            <a:ext cx="1457280" cy="920880"/>
          </a:xfrm>
          <a:prstGeom prst="rect">
            <a:avLst/>
          </a:prstGeom>
          <a:ln w="0">
            <a:noFill/>
          </a:ln>
        </p:spPr>
      </p:pic>
      <p:pic>
        <p:nvPicPr>
          <p:cNvPr id="43" name="Chart 147" descr=""/>
          <p:cNvPicPr/>
          <p:nvPr/>
        </p:nvPicPr>
        <p:blipFill>
          <a:blip r:embed="rId3"/>
          <a:stretch/>
        </p:blipFill>
        <p:spPr>
          <a:xfrm>
            <a:off x="4492800" y="1073160"/>
            <a:ext cx="1377720" cy="1133640"/>
          </a:xfrm>
          <a:prstGeom prst="rect">
            <a:avLst/>
          </a:prstGeom>
          <a:ln w="0">
            <a:noFill/>
          </a:ln>
        </p:spPr>
      </p:pic>
      <p:pic>
        <p:nvPicPr>
          <p:cNvPr id="44" name="Chart 148" descr=""/>
          <p:cNvPicPr/>
          <p:nvPr/>
        </p:nvPicPr>
        <p:blipFill>
          <a:blip r:embed="rId4"/>
          <a:stretch/>
        </p:blipFill>
        <p:spPr>
          <a:xfrm>
            <a:off x="4565520" y="2017800"/>
            <a:ext cx="1305000" cy="993600"/>
          </a:xfrm>
          <a:prstGeom prst="rect">
            <a:avLst/>
          </a:prstGeom>
          <a:ln w="0">
            <a:noFill/>
          </a:ln>
        </p:spPr>
      </p:pic>
      <p:pic>
        <p:nvPicPr>
          <p:cNvPr id="45" name="Chart 116" descr=""/>
          <p:cNvPicPr/>
          <p:nvPr/>
        </p:nvPicPr>
        <p:blipFill>
          <a:blip r:embed="rId5"/>
          <a:stretch/>
        </p:blipFill>
        <p:spPr>
          <a:xfrm>
            <a:off x="3121200" y="1133640"/>
            <a:ext cx="1401480" cy="1006200"/>
          </a:xfrm>
          <a:prstGeom prst="rect">
            <a:avLst/>
          </a:prstGeom>
          <a:ln w="0">
            <a:noFill/>
          </a:ln>
        </p:spPr>
      </p:pic>
      <p:pic>
        <p:nvPicPr>
          <p:cNvPr id="46" name="Chart 141" descr=""/>
          <p:cNvPicPr/>
          <p:nvPr/>
        </p:nvPicPr>
        <p:blipFill>
          <a:blip r:embed="rId6"/>
          <a:stretch/>
        </p:blipFill>
        <p:spPr>
          <a:xfrm>
            <a:off x="378000" y="2932200"/>
            <a:ext cx="1377720" cy="1079280"/>
          </a:xfrm>
          <a:prstGeom prst="rect">
            <a:avLst/>
          </a:prstGeom>
          <a:ln w="0">
            <a:noFill/>
          </a:ln>
        </p:spPr>
      </p:pic>
      <p:pic>
        <p:nvPicPr>
          <p:cNvPr id="47" name="Chart 130" descr=""/>
          <p:cNvPicPr/>
          <p:nvPr/>
        </p:nvPicPr>
        <p:blipFill>
          <a:blip r:embed="rId7"/>
          <a:stretch/>
        </p:blipFill>
        <p:spPr>
          <a:xfrm>
            <a:off x="3121200" y="1944720"/>
            <a:ext cx="1609560" cy="1152360"/>
          </a:xfrm>
          <a:prstGeom prst="rect">
            <a:avLst/>
          </a:prstGeom>
          <a:ln w="0">
            <a:noFill/>
          </a:ln>
        </p:spPr>
      </p:pic>
      <p:pic>
        <p:nvPicPr>
          <p:cNvPr id="48" name="Chart 97" descr=""/>
          <p:cNvPicPr/>
          <p:nvPr/>
        </p:nvPicPr>
        <p:blipFill>
          <a:blip r:embed="rId8"/>
          <a:stretch/>
        </p:blipFill>
        <p:spPr>
          <a:xfrm>
            <a:off x="1749600" y="2090880"/>
            <a:ext cx="1365120" cy="907920"/>
          </a:xfrm>
          <a:prstGeom prst="rect">
            <a:avLst/>
          </a:prstGeom>
          <a:ln w="0">
            <a:noFill/>
          </a:ln>
        </p:spPr>
      </p:pic>
      <p:pic>
        <p:nvPicPr>
          <p:cNvPr id="49" name="Chart 103" descr=""/>
          <p:cNvPicPr/>
          <p:nvPr/>
        </p:nvPicPr>
        <p:blipFill>
          <a:blip r:embed="rId9"/>
          <a:stretch/>
        </p:blipFill>
        <p:spPr>
          <a:xfrm>
            <a:off x="1749600" y="1146240"/>
            <a:ext cx="1377720" cy="938160"/>
          </a:xfrm>
          <a:prstGeom prst="rect">
            <a:avLst/>
          </a:prstGeom>
          <a:ln w="0">
            <a:noFill/>
          </a:ln>
        </p:spPr>
      </p:pic>
      <p:sp>
        <p:nvSpPr>
          <p:cNvPr id="50" name="TextBox 54"/>
          <p:cNvSpPr/>
          <p:nvPr/>
        </p:nvSpPr>
        <p:spPr>
          <a:xfrm>
            <a:off x="152280" y="4354560"/>
            <a:ext cx="533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55"/>
          <p:cNvSpPr/>
          <p:nvPr/>
        </p:nvSpPr>
        <p:spPr>
          <a:xfrm>
            <a:off x="76320" y="196920"/>
            <a:ext cx="2338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58"/>
          <p:cNvSpPr/>
          <p:nvPr/>
        </p:nvSpPr>
        <p:spPr>
          <a:xfrm>
            <a:off x="765360" y="577800"/>
            <a:ext cx="909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ell cycle arres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ight Bracket 59"/>
          <p:cNvSpPr/>
          <p:nvPr/>
        </p:nvSpPr>
        <p:spPr>
          <a:xfrm rot="16200000">
            <a:off x="1180800" y="433080"/>
            <a:ext cx="46080" cy="1189080"/>
          </a:xfrm>
          <a:custGeom>
            <a:avLst/>
            <a:gdLst>
              <a:gd name="textAreaLeft" fmla="*/ 0 w 46080"/>
              <a:gd name="textAreaRight" fmla="*/ 32400 w 46080"/>
              <a:gd name="textAreaTop" fmla="*/ 1800 h 1189080"/>
              <a:gd name="textAreaBottom" fmla="*/ 1187280 h 11890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35"/>
                  <a:pt x="21600" y="69"/>
                </a:cubicBezTo>
                <a:lnTo>
                  <a:pt x="21600" y="21531"/>
                </a:lnTo>
                <a:cubicBezTo>
                  <a:pt x="21600" y="21566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4" name="Group 60"/>
          <p:cNvGrpSpPr/>
          <p:nvPr/>
        </p:nvGrpSpPr>
        <p:grpSpPr>
          <a:xfrm>
            <a:off x="5943600" y="1081080"/>
            <a:ext cx="681480" cy="368280"/>
            <a:chOff x="5943600" y="1081080"/>
            <a:chExt cx="681480" cy="368280"/>
          </a:xfrm>
        </p:grpSpPr>
        <p:sp>
          <p:nvSpPr>
            <p:cNvPr id="55" name="TextBox 61"/>
            <p:cNvSpPr/>
            <p:nvPr/>
          </p:nvSpPr>
          <p:spPr>
            <a:xfrm>
              <a:off x="6025320" y="1233720"/>
              <a:ext cx="599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OVCAR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Box 62"/>
            <p:cNvSpPr/>
            <p:nvPr/>
          </p:nvSpPr>
          <p:spPr>
            <a:xfrm>
              <a:off x="6025320" y="1081080"/>
              <a:ext cx="599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OVCAR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ectangle 63"/>
            <p:cNvSpPr/>
            <p:nvPr/>
          </p:nvSpPr>
          <p:spPr>
            <a:xfrm>
              <a:off x="5943600" y="1294560"/>
              <a:ext cx="91440" cy="91440"/>
            </a:xfrm>
            <a:prstGeom prst="rect">
              <a:avLst/>
            </a:prstGeom>
            <a:solidFill>
              <a:srgbClr val="b2b2b2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64"/>
            <p:cNvSpPr/>
            <p:nvPr/>
          </p:nvSpPr>
          <p:spPr>
            <a:xfrm>
              <a:off x="5943600" y="1129320"/>
              <a:ext cx="91440" cy="91440"/>
            </a:xfrm>
            <a:prstGeom prst="rect">
              <a:avLst/>
            </a:prstGeom>
            <a:solidFill>
              <a:srgbClr val="60606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9" name="TextBox 65"/>
          <p:cNvSpPr/>
          <p:nvPr/>
        </p:nvSpPr>
        <p:spPr>
          <a:xfrm rot="16200000">
            <a:off x="-572760" y="2523960"/>
            <a:ext cx="1787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elative expression (arbitrary units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ight Bracket 66"/>
          <p:cNvSpPr/>
          <p:nvPr/>
        </p:nvSpPr>
        <p:spPr>
          <a:xfrm rot="16200000">
            <a:off x="3924000" y="433080"/>
            <a:ext cx="46080" cy="1189080"/>
          </a:xfrm>
          <a:custGeom>
            <a:avLst/>
            <a:gdLst>
              <a:gd name="textAreaLeft" fmla="*/ 0 w 46080"/>
              <a:gd name="textAreaRight" fmla="*/ 32400 w 46080"/>
              <a:gd name="textAreaTop" fmla="*/ 1800 h 1189080"/>
              <a:gd name="textAreaBottom" fmla="*/ 1187280 h 11890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35"/>
                  <a:pt x="21600" y="69"/>
                </a:cubicBezTo>
                <a:lnTo>
                  <a:pt x="21600" y="21531"/>
                </a:lnTo>
                <a:cubicBezTo>
                  <a:pt x="21600" y="21566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ight Bracket 67"/>
          <p:cNvSpPr/>
          <p:nvPr/>
        </p:nvSpPr>
        <p:spPr>
          <a:xfrm rot="16200000">
            <a:off x="5219640" y="433080"/>
            <a:ext cx="46080" cy="1189080"/>
          </a:xfrm>
          <a:custGeom>
            <a:avLst/>
            <a:gdLst>
              <a:gd name="textAreaLeft" fmla="*/ 0 w 46080"/>
              <a:gd name="textAreaRight" fmla="*/ 32400 w 46080"/>
              <a:gd name="textAreaTop" fmla="*/ 1800 h 1189080"/>
              <a:gd name="textAreaBottom" fmla="*/ 1187280 h 11890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35"/>
                  <a:pt x="21600" y="69"/>
                </a:cubicBezTo>
                <a:lnTo>
                  <a:pt x="21600" y="21531"/>
                </a:lnTo>
                <a:cubicBezTo>
                  <a:pt x="21600" y="21566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68"/>
          <p:cNvSpPr/>
          <p:nvPr/>
        </p:nvSpPr>
        <p:spPr>
          <a:xfrm>
            <a:off x="1905120" y="577800"/>
            <a:ext cx="1523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DNA replication, Metastasis and Apoptosis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69"/>
          <p:cNvSpPr/>
          <p:nvPr/>
        </p:nvSpPr>
        <p:spPr>
          <a:xfrm>
            <a:off x="3890880" y="2101680"/>
            <a:ext cx="520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CBE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70"/>
          <p:cNvSpPr/>
          <p:nvPr/>
        </p:nvSpPr>
        <p:spPr>
          <a:xfrm>
            <a:off x="2412000" y="1111320"/>
            <a:ext cx="480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CM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71"/>
          <p:cNvSpPr/>
          <p:nvPr/>
        </p:nvSpPr>
        <p:spPr>
          <a:xfrm>
            <a:off x="2411280" y="2101680"/>
            <a:ext cx="397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E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72"/>
          <p:cNvSpPr/>
          <p:nvPr/>
        </p:nvSpPr>
        <p:spPr>
          <a:xfrm>
            <a:off x="1071720" y="2101680"/>
            <a:ext cx="525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CNB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73"/>
          <p:cNvSpPr/>
          <p:nvPr/>
        </p:nvSpPr>
        <p:spPr>
          <a:xfrm>
            <a:off x="1073160" y="1111320"/>
            <a:ext cx="823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DC2 (CDK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74"/>
          <p:cNvSpPr/>
          <p:nvPr/>
        </p:nvSpPr>
        <p:spPr>
          <a:xfrm>
            <a:off x="3890520" y="1111320"/>
            <a:ext cx="50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AFAP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75"/>
          <p:cNvSpPr/>
          <p:nvPr/>
        </p:nvSpPr>
        <p:spPr>
          <a:xfrm>
            <a:off x="4880160" y="1111320"/>
            <a:ext cx="520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DUSP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76"/>
          <p:cNvSpPr/>
          <p:nvPr/>
        </p:nvSpPr>
        <p:spPr>
          <a:xfrm>
            <a:off x="4878720" y="2101680"/>
            <a:ext cx="534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NFkBI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1" name="Group 77"/>
          <p:cNvGrpSpPr/>
          <p:nvPr/>
        </p:nvGrpSpPr>
        <p:grpSpPr>
          <a:xfrm>
            <a:off x="636120" y="3854520"/>
            <a:ext cx="1201680" cy="185400"/>
            <a:chOff x="636120" y="3854520"/>
            <a:chExt cx="1201680" cy="185400"/>
          </a:xfrm>
        </p:grpSpPr>
        <p:sp>
          <p:nvSpPr>
            <p:cNvPr id="72" name="TextBox 78"/>
            <p:cNvSpPr/>
            <p:nvPr/>
          </p:nvSpPr>
          <p:spPr>
            <a:xfrm>
              <a:off x="636120" y="3854520"/>
              <a:ext cx="3636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ock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TextBox 79"/>
            <p:cNvSpPr/>
            <p:nvPr/>
          </p:nvSpPr>
          <p:spPr>
            <a:xfrm>
              <a:off x="929160" y="3854520"/>
              <a:ext cx="2995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I3C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TextBox 80"/>
            <p:cNvSpPr/>
            <p:nvPr/>
          </p:nvSpPr>
          <p:spPr>
            <a:xfrm>
              <a:off x="1213200" y="3854520"/>
              <a:ext cx="3236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Bort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TextBox 81"/>
            <p:cNvSpPr/>
            <p:nvPr/>
          </p:nvSpPr>
          <p:spPr>
            <a:xfrm>
              <a:off x="1452960" y="3854520"/>
              <a:ext cx="3848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Comb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6" name="Group 82"/>
          <p:cNvGrpSpPr/>
          <p:nvPr/>
        </p:nvGrpSpPr>
        <p:grpSpPr>
          <a:xfrm>
            <a:off x="1996560" y="3854520"/>
            <a:ext cx="1200600" cy="185400"/>
            <a:chOff x="1996560" y="3854520"/>
            <a:chExt cx="1200600" cy="185400"/>
          </a:xfrm>
        </p:grpSpPr>
        <p:sp>
          <p:nvSpPr>
            <p:cNvPr id="77" name="TextBox 83"/>
            <p:cNvSpPr/>
            <p:nvPr/>
          </p:nvSpPr>
          <p:spPr>
            <a:xfrm>
              <a:off x="1996560" y="3854520"/>
              <a:ext cx="3636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ock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TextBox 84"/>
            <p:cNvSpPr/>
            <p:nvPr/>
          </p:nvSpPr>
          <p:spPr>
            <a:xfrm>
              <a:off x="2289240" y="3854520"/>
              <a:ext cx="2995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I3C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TextBox 85"/>
            <p:cNvSpPr/>
            <p:nvPr/>
          </p:nvSpPr>
          <p:spPr>
            <a:xfrm>
              <a:off x="2573280" y="3854520"/>
              <a:ext cx="3229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Bort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TextBox 86"/>
            <p:cNvSpPr/>
            <p:nvPr/>
          </p:nvSpPr>
          <p:spPr>
            <a:xfrm>
              <a:off x="2812320" y="3854520"/>
              <a:ext cx="3848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Comb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1" name="Group 87"/>
          <p:cNvGrpSpPr/>
          <p:nvPr/>
        </p:nvGrpSpPr>
        <p:grpSpPr>
          <a:xfrm>
            <a:off x="3368160" y="3854520"/>
            <a:ext cx="1200600" cy="185400"/>
            <a:chOff x="3368160" y="3854520"/>
            <a:chExt cx="1200600" cy="185400"/>
          </a:xfrm>
        </p:grpSpPr>
        <p:sp>
          <p:nvSpPr>
            <p:cNvPr id="82" name="TextBox 88"/>
            <p:cNvSpPr/>
            <p:nvPr/>
          </p:nvSpPr>
          <p:spPr>
            <a:xfrm>
              <a:off x="3368160" y="3854520"/>
              <a:ext cx="3636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ock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TextBox 89"/>
            <p:cNvSpPr/>
            <p:nvPr/>
          </p:nvSpPr>
          <p:spPr>
            <a:xfrm>
              <a:off x="3660840" y="3854520"/>
              <a:ext cx="2995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I3C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TextBox 90"/>
            <p:cNvSpPr/>
            <p:nvPr/>
          </p:nvSpPr>
          <p:spPr>
            <a:xfrm>
              <a:off x="3944880" y="3854520"/>
              <a:ext cx="3229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Bort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TextBox 91"/>
            <p:cNvSpPr/>
            <p:nvPr/>
          </p:nvSpPr>
          <p:spPr>
            <a:xfrm>
              <a:off x="4183920" y="3854520"/>
              <a:ext cx="3848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Comb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6" name="Group 92"/>
          <p:cNvGrpSpPr/>
          <p:nvPr/>
        </p:nvGrpSpPr>
        <p:grpSpPr>
          <a:xfrm>
            <a:off x="4739760" y="3854520"/>
            <a:ext cx="1200600" cy="185400"/>
            <a:chOff x="4739760" y="3854520"/>
            <a:chExt cx="1200600" cy="185400"/>
          </a:xfrm>
        </p:grpSpPr>
        <p:sp>
          <p:nvSpPr>
            <p:cNvPr id="87" name="TextBox 93"/>
            <p:cNvSpPr/>
            <p:nvPr/>
          </p:nvSpPr>
          <p:spPr>
            <a:xfrm>
              <a:off x="4739760" y="3854520"/>
              <a:ext cx="3636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ock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TextBox 94"/>
            <p:cNvSpPr/>
            <p:nvPr/>
          </p:nvSpPr>
          <p:spPr>
            <a:xfrm>
              <a:off x="5032440" y="3854520"/>
              <a:ext cx="2995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I3C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TextBox 95"/>
            <p:cNvSpPr/>
            <p:nvPr/>
          </p:nvSpPr>
          <p:spPr>
            <a:xfrm>
              <a:off x="5316480" y="3854520"/>
              <a:ext cx="3229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Bort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TextBox 96"/>
            <p:cNvSpPr/>
            <p:nvPr/>
          </p:nvSpPr>
          <p:spPr>
            <a:xfrm>
              <a:off x="5555520" y="3854520"/>
              <a:ext cx="3848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Comb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1" name="Right Bracket 98"/>
          <p:cNvSpPr/>
          <p:nvPr/>
        </p:nvSpPr>
        <p:spPr>
          <a:xfrm rot="16200000">
            <a:off x="2628720" y="433080"/>
            <a:ext cx="46080" cy="1189080"/>
          </a:xfrm>
          <a:custGeom>
            <a:avLst/>
            <a:gdLst>
              <a:gd name="textAreaLeft" fmla="*/ 0 w 46080"/>
              <a:gd name="textAreaRight" fmla="*/ 32400 w 46080"/>
              <a:gd name="textAreaTop" fmla="*/ 1800 h 1189080"/>
              <a:gd name="textAreaBottom" fmla="*/ 1187280 h 11890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35"/>
                  <a:pt x="21600" y="69"/>
                </a:cubicBezTo>
                <a:lnTo>
                  <a:pt x="21600" y="21531"/>
                </a:lnTo>
                <a:cubicBezTo>
                  <a:pt x="21600" y="21566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Box 128"/>
          <p:cNvSpPr/>
          <p:nvPr/>
        </p:nvSpPr>
        <p:spPr>
          <a:xfrm>
            <a:off x="3352680" y="577800"/>
            <a:ext cx="12956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ytoskeletal regulators and Centrosome/mitotic spindle apparatus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Box 129"/>
          <p:cNvSpPr/>
          <p:nvPr/>
        </p:nvSpPr>
        <p:spPr>
          <a:xfrm>
            <a:off x="4648320" y="577800"/>
            <a:ext cx="12189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Signal transduction pathway and Drug metabolis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Box 142"/>
          <p:cNvSpPr/>
          <p:nvPr/>
        </p:nvSpPr>
        <p:spPr>
          <a:xfrm>
            <a:off x="1070640" y="3048120"/>
            <a:ext cx="598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DKN1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5" name="Chart 143" descr=""/>
          <p:cNvPicPr/>
          <p:nvPr/>
        </p:nvPicPr>
        <p:blipFill>
          <a:blip r:embed="rId10"/>
          <a:stretch/>
        </p:blipFill>
        <p:spPr>
          <a:xfrm>
            <a:off x="1749600" y="2932200"/>
            <a:ext cx="1500120" cy="1079280"/>
          </a:xfrm>
          <a:prstGeom prst="rect">
            <a:avLst/>
          </a:prstGeom>
          <a:ln w="0">
            <a:noFill/>
          </a:ln>
        </p:spPr>
      </p:pic>
      <p:sp>
        <p:nvSpPr>
          <p:cNvPr id="96" name="TextBox 144"/>
          <p:cNvSpPr/>
          <p:nvPr/>
        </p:nvSpPr>
        <p:spPr>
          <a:xfrm>
            <a:off x="2414520" y="3048120"/>
            <a:ext cx="547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BCL2L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7" name="Chart 145" descr=""/>
          <p:cNvPicPr/>
          <p:nvPr/>
        </p:nvPicPr>
        <p:blipFill>
          <a:blip r:embed="rId11"/>
          <a:stretch/>
        </p:blipFill>
        <p:spPr>
          <a:xfrm>
            <a:off x="3121200" y="2932200"/>
            <a:ext cx="1530000" cy="1079280"/>
          </a:xfrm>
          <a:prstGeom prst="rect">
            <a:avLst/>
          </a:prstGeom>
          <a:ln w="0">
            <a:noFill/>
          </a:ln>
        </p:spPr>
      </p:pic>
      <p:sp>
        <p:nvSpPr>
          <p:cNvPr id="98" name="TextBox 146"/>
          <p:cNvSpPr/>
          <p:nvPr/>
        </p:nvSpPr>
        <p:spPr>
          <a:xfrm>
            <a:off x="3890160" y="3048120"/>
            <a:ext cx="526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ENPF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Box 152"/>
          <p:cNvSpPr/>
          <p:nvPr/>
        </p:nvSpPr>
        <p:spPr>
          <a:xfrm>
            <a:off x="4876920" y="3048120"/>
            <a:ext cx="609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YP1A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0" name="Chart 122" descr=""/>
          <p:cNvPicPr/>
          <p:nvPr/>
        </p:nvPicPr>
        <p:blipFill>
          <a:blip r:embed="rId12"/>
          <a:stretch/>
        </p:blipFill>
        <p:spPr>
          <a:xfrm>
            <a:off x="378000" y="2054160"/>
            <a:ext cx="1420560" cy="920880"/>
          </a:xfrm>
          <a:prstGeom prst="rect">
            <a:avLst/>
          </a:prstGeom>
          <a:ln w="0">
            <a:noFill/>
          </a:ln>
        </p:spPr>
      </p:pic>
      <p:pic>
        <p:nvPicPr>
          <p:cNvPr id="101" name="Picture 2" descr=""/>
          <p:cNvPicPr/>
          <p:nvPr/>
        </p:nvPicPr>
        <p:blipFill>
          <a:blip r:embed="rId13"/>
          <a:srcRect l="34688" t="21250" r="41251" b="10000"/>
          <a:stretch/>
        </p:blipFill>
        <p:spPr>
          <a:xfrm>
            <a:off x="1752480" y="5334120"/>
            <a:ext cx="1760760" cy="3771720"/>
          </a:xfrm>
          <a:prstGeom prst="rect">
            <a:avLst/>
          </a:prstGeom>
          <a:ln w="0">
            <a:noFill/>
          </a:ln>
        </p:spPr>
      </p:pic>
      <p:sp>
        <p:nvSpPr>
          <p:cNvPr id="102" name="Text Box 11"/>
          <p:cNvSpPr/>
          <p:nvPr/>
        </p:nvSpPr>
        <p:spPr>
          <a:xfrm rot="16200000">
            <a:off x="1764720" y="5086800"/>
            <a:ext cx="42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ock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 Box 12"/>
          <p:cNvSpPr/>
          <p:nvPr/>
        </p:nvSpPr>
        <p:spPr>
          <a:xfrm rot="16200000">
            <a:off x="2008080" y="5129640"/>
            <a:ext cx="339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I3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 Box 13"/>
          <p:cNvSpPr/>
          <p:nvPr/>
        </p:nvSpPr>
        <p:spPr>
          <a:xfrm rot="16200000">
            <a:off x="2160360" y="5115960"/>
            <a:ext cx="368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Bor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 Box 14"/>
          <p:cNvSpPr/>
          <p:nvPr/>
        </p:nvSpPr>
        <p:spPr>
          <a:xfrm rot="16200000">
            <a:off x="2169720" y="4920120"/>
            <a:ext cx="752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ombina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 Box 15"/>
          <p:cNvSpPr/>
          <p:nvPr/>
        </p:nvSpPr>
        <p:spPr>
          <a:xfrm rot="16200000">
            <a:off x="2517120" y="5086800"/>
            <a:ext cx="42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ock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 Box 16"/>
          <p:cNvSpPr/>
          <p:nvPr/>
        </p:nvSpPr>
        <p:spPr>
          <a:xfrm rot="16200000">
            <a:off x="2739960" y="5129640"/>
            <a:ext cx="339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I3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 Box 17"/>
          <p:cNvSpPr/>
          <p:nvPr/>
        </p:nvSpPr>
        <p:spPr>
          <a:xfrm rot="16200000">
            <a:off x="2908080" y="5115960"/>
            <a:ext cx="368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Bor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 Box 18"/>
          <p:cNvSpPr/>
          <p:nvPr/>
        </p:nvSpPr>
        <p:spPr>
          <a:xfrm rot="16200000">
            <a:off x="2931840" y="4920120"/>
            <a:ext cx="752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ombina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0" name="Group 118"/>
          <p:cNvGrpSpPr/>
          <p:nvPr/>
        </p:nvGrpSpPr>
        <p:grpSpPr>
          <a:xfrm>
            <a:off x="1905120" y="4272120"/>
            <a:ext cx="1539720" cy="261720"/>
            <a:chOff x="1905120" y="4272120"/>
            <a:chExt cx="1539720" cy="261720"/>
          </a:xfrm>
        </p:grpSpPr>
        <p:sp>
          <p:nvSpPr>
            <p:cNvPr id="111" name="Line 21"/>
            <p:cNvSpPr/>
            <p:nvPr/>
          </p:nvSpPr>
          <p:spPr>
            <a:xfrm>
              <a:off x="1905120" y="4533840"/>
              <a:ext cx="7318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Line 22"/>
            <p:cNvSpPr/>
            <p:nvPr/>
          </p:nvSpPr>
          <p:spPr>
            <a:xfrm>
              <a:off x="2712960" y="4533840"/>
              <a:ext cx="7318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Text Box 55"/>
            <p:cNvSpPr/>
            <p:nvPr/>
          </p:nvSpPr>
          <p:spPr>
            <a:xfrm>
              <a:off x="1986840" y="4272120"/>
              <a:ext cx="599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OVCAR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Text Box 56"/>
            <p:cNvSpPr/>
            <p:nvPr/>
          </p:nvSpPr>
          <p:spPr>
            <a:xfrm>
              <a:off x="2747520" y="4272120"/>
              <a:ext cx="599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OVCAR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5" name="Rectangle 7"/>
          <p:cNvSpPr/>
          <p:nvPr/>
        </p:nvSpPr>
        <p:spPr>
          <a:xfrm>
            <a:off x="4419720" y="5651640"/>
            <a:ext cx="1143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ell cycle regula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Rectangle 7"/>
          <p:cNvSpPr/>
          <p:nvPr/>
        </p:nvSpPr>
        <p:spPr>
          <a:xfrm>
            <a:off x="4419720" y="6956280"/>
            <a:ext cx="1676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etastasis and Angiogenesi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Rectangle 139"/>
          <p:cNvSpPr/>
          <p:nvPr/>
        </p:nvSpPr>
        <p:spPr>
          <a:xfrm>
            <a:off x="4422960" y="6413400"/>
            <a:ext cx="909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ell cycle arres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Rectangle 3"/>
          <p:cNvSpPr/>
          <p:nvPr/>
        </p:nvSpPr>
        <p:spPr>
          <a:xfrm>
            <a:off x="3429000" y="5346720"/>
            <a:ext cx="762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Rectangle 4"/>
          <p:cNvSpPr/>
          <p:nvPr/>
        </p:nvSpPr>
        <p:spPr>
          <a:xfrm>
            <a:off x="3429000" y="5616720"/>
            <a:ext cx="914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pRB 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</a:rPr>
              <a:t>S807/S81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Rectangle 6"/>
          <p:cNvSpPr/>
          <p:nvPr/>
        </p:nvSpPr>
        <p:spPr>
          <a:xfrm>
            <a:off x="3429000" y="8804160"/>
            <a:ext cx="762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Act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Rectangle 7"/>
          <p:cNvSpPr/>
          <p:nvPr/>
        </p:nvSpPr>
        <p:spPr>
          <a:xfrm>
            <a:off x="3429000" y="8263080"/>
            <a:ext cx="762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ATF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Rectangle 7"/>
          <p:cNvSpPr/>
          <p:nvPr/>
        </p:nvSpPr>
        <p:spPr>
          <a:xfrm>
            <a:off x="3429000" y="6956280"/>
            <a:ext cx="762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E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Rectangle 7"/>
          <p:cNvSpPr/>
          <p:nvPr/>
        </p:nvSpPr>
        <p:spPr>
          <a:xfrm>
            <a:off x="3429000" y="8534520"/>
            <a:ext cx="762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YP1B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Rectangle 7"/>
          <p:cNvSpPr/>
          <p:nvPr/>
        </p:nvSpPr>
        <p:spPr>
          <a:xfrm>
            <a:off x="3429000" y="7772400"/>
            <a:ext cx="762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TOP2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Rectangle 76"/>
          <p:cNvSpPr/>
          <p:nvPr/>
        </p:nvSpPr>
        <p:spPr>
          <a:xfrm>
            <a:off x="3429000" y="6696000"/>
            <a:ext cx="838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GADD45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Rectangle 84"/>
          <p:cNvSpPr/>
          <p:nvPr/>
        </p:nvSpPr>
        <p:spPr>
          <a:xfrm>
            <a:off x="3429000" y="7234200"/>
            <a:ext cx="762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SNA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Rectangle 69"/>
          <p:cNvSpPr/>
          <p:nvPr/>
        </p:nvSpPr>
        <p:spPr>
          <a:xfrm>
            <a:off x="3429000" y="5915160"/>
            <a:ext cx="762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DK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Right Bracket 159"/>
          <p:cNvSpPr/>
          <p:nvPr/>
        </p:nvSpPr>
        <p:spPr>
          <a:xfrm>
            <a:off x="4191120" y="5334120"/>
            <a:ext cx="75960" cy="731880"/>
          </a:xfrm>
          <a:custGeom>
            <a:avLst/>
            <a:gdLst>
              <a:gd name="textAreaLeft" fmla="*/ 0 w 75960"/>
              <a:gd name="textAreaRight" fmla="*/ 53280 w 75960"/>
              <a:gd name="textAreaTop" fmla="*/ 2880 h 731880"/>
              <a:gd name="textAreaBottom" fmla="*/ 729000 h 7318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94"/>
                  <a:pt x="21600" y="187"/>
                </a:cubicBezTo>
                <a:lnTo>
                  <a:pt x="21600" y="21413"/>
                </a:lnTo>
                <a:cubicBezTo>
                  <a:pt x="21600" y="21507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Rectangle 160"/>
          <p:cNvSpPr/>
          <p:nvPr/>
        </p:nvSpPr>
        <p:spPr>
          <a:xfrm>
            <a:off x="4425120" y="7745400"/>
            <a:ext cx="895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Drug resistanc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Rectangle 161"/>
          <p:cNvSpPr/>
          <p:nvPr/>
        </p:nvSpPr>
        <p:spPr>
          <a:xfrm>
            <a:off x="4421880" y="8271000"/>
            <a:ext cx="625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ER stres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Rectangle 162"/>
          <p:cNvSpPr/>
          <p:nvPr/>
        </p:nvSpPr>
        <p:spPr>
          <a:xfrm>
            <a:off x="4424760" y="8534520"/>
            <a:ext cx="951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Drug metabolis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Right Bracket 163"/>
          <p:cNvSpPr/>
          <p:nvPr/>
        </p:nvSpPr>
        <p:spPr>
          <a:xfrm>
            <a:off x="4191120" y="7761240"/>
            <a:ext cx="75960" cy="182520"/>
          </a:xfrm>
          <a:custGeom>
            <a:avLst/>
            <a:gdLst>
              <a:gd name="textAreaLeft" fmla="*/ 0 w 75960"/>
              <a:gd name="textAreaRight" fmla="*/ 53280 w 75960"/>
              <a:gd name="textAreaTop" fmla="*/ 2880 h 182520"/>
              <a:gd name="textAreaBottom" fmla="*/ 179640 h 1825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375"/>
                  <a:pt x="21600" y="750"/>
                </a:cubicBezTo>
                <a:lnTo>
                  <a:pt x="21600" y="20850"/>
                </a:lnTo>
                <a:cubicBezTo>
                  <a:pt x="21600" y="21225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Right Bracket 164"/>
          <p:cNvSpPr/>
          <p:nvPr/>
        </p:nvSpPr>
        <p:spPr>
          <a:xfrm>
            <a:off x="4191120" y="8288280"/>
            <a:ext cx="75960" cy="182520"/>
          </a:xfrm>
          <a:custGeom>
            <a:avLst/>
            <a:gdLst>
              <a:gd name="textAreaLeft" fmla="*/ 0 w 75960"/>
              <a:gd name="textAreaRight" fmla="*/ 53280 w 75960"/>
              <a:gd name="textAreaTop" fmla="*/ 2880 h 182520"/>
              <a:gd name="textAreaBottom" fmla="*/ 179640 h 1825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375"/>
                  <a:pt x="21600" y="750"/>
                </a:cubicBezTo>
                <a:lnTo>
                  <a:pt x="21600" y="20850"/>
                </a:lnTo>
                <a:cubicBezTo>
                  <a:pt x="21600" y="21225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Right Bracket 165"/>
          <p:cNvSpPr/>
          <p:nvPr/>
        </p:nvSpPr>
        <p:spPr>
          <a:xfrm>
            <a:off x="4191120" y="8550360"/>
            <a:ext cx="75960" cy="182520"/>
          </a:xfrm>
          <a:custGeom>
            <a:avLst/>
            <a:gdLst>
              <a:gd name="textAreaLeft" fmla="*/ 0 w 75960"/>
              <a:gd name="textAreaRight" fmla="*/ 53280 w 75960"/>
              <a:gd name="textAreaTop" fmla="*/ 2880 h 182520"/>
              <a:gd name="textAreaBottom" fmla="*/ 179640 h 1825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375"/>
                  <a:pt x="21600" y="750"/>
                </a:cubicBezTo>
                <a:lnTo>
                  <a:pt x="21600" y="20850"/>
                </a:lnTo>
                <a:cubicBezTo>
                  <a:pt x="21600" y="21225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Right Bracket 166"/>
          <p:cNvSpPr/>
          <p:nvPr/>
        </p:nvSpPr>
        <p:spPr>
          <a:xfrm>
            <a:off x="4191120" y="6202440"/>
            <a:ext cx="75960" cy="731880"/>
          </a:xfrm>
          <a:custGeom>
            <a:avLst/>
            <a:gdLst>
              <a:gd name="textAreaLeft" fmla="*/ 0 w 75960"/>
              <a:gd name="textAreaRight" fmla="*/ 53280 w 75960"/>
              <a:gd name="textAreaTop" fmla="*/ 2880 h 731880"/>
              <a:gd name="textAreaBottom" fmla="*/ 729000 h 7318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94"/>
                  <a:pt x="21600" y="187"/>
                </a:cubicBezTo>
                <a:lnTo>
                  <a:pt x="21600" y="21413"/>
                </a:lnTo>
                <a:cubicBezTo>
                  <a:pt x="21600" y="21507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Rectangle 76"/>
          <p:cNvSpPr/>
          <p:nvPr/>
        </p:nvSpPr>
        <p:spPr>
          <a:xfrm>
            <a:off x="3429000" y="6184800"/>
            <a:ext cx="762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21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</a:rPr>
              <a:t>cip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Rectangle 76"/>
          <p:cNvSpPr/>
          <p:nvPr/>
        </p:nvSpPr>
        <p:spPr>
          <a:xfrm>
            <a:off x="3429000" y="7504200"/>
            <a:ext cx="838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TBNN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Right Bracket 169"/>
          <p:cNvSpPr/>
          <p:nvPr/>
        </p:nvSpPr>
        <p:spPr>
          <a:xfrm>
            <a:off x="4191120" y="6972480"/>
            <a:ext cx="75960" cy="182520"/>
          </a:xfrm>
          <a:custGeom>
            <a:avLst/>
            <a:gdLst>
              <a:gd name="textAreaLeft" fmla="*/ 0 w 75960"/>
              <a:gd name="textAreaRight" fmla="*/ 53280 w 75960"/>
              <a:gd name="textAreaTop" fmla="*/ 2880 h 182520"/>
              <a:gd name="textAreaBottom" fmla="*/ 179640 h 1825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375"/>
                  <a:pt x="21600" y="750"/>
                </a:cubicBezTo>
                <a:lnTo>
                  <a:pt x="21600" y="20850"/>
                </a:lnTo>
                <a:cubicBezTo>
                  <a:pt x="21600" y="21225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Right Bracket 170"/>
          <p:cNvSpPr/>
          <p:nvPr/>
        </p:nvSpPr>
        <p:spPr>
          <a:xfrm>
            <a:off x="4191120" y="7236000"/>
            <a:ext cx="75960" cy="182520"/>
          </a:xfrm>
          <a:custGeom>
            <a:avLst/>
            <a:gdLst>
              <a:gd name="textAreaLeft" fmla="*/ 0 w 75960"/>
              <a:gd name="textAreaRight" fmla="*/ 53280 w 75960"/>
              <a:gd name="textAreaTop" fmla="*/ 2880 h 182520"/>
              <a:gd name="textAreaBottom" fmla="*/ 179640 h 1825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375"/>
                  <a:pt x="21600" y="750"/>
                </a:cubicBezTo>
                <a:lnTo>
                  <a:pt x="21600" y="20850"/>
                </a:lnTo>
                <a:cubicBezTo>
                  <a:pt x="21600" y="21225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Right Bracket 171"/>
          <p:cNvSpPr/>
          <p:nvPr/>
        </p:nvSpPr>
        <p:spPr>
          <a:xfrm>
            <a:off x="4191120" y="7497720"/>
            <a:ext cx="75960" cy="184320"/>
          </a:xfrm>
          <a:custGeom>
            <a:avLst/>
            <a:gdLst>
              <a:gd name="textAreaLeft" fmla="*/ 0 w 75960"/>
              <a:gd name="textAreaRight" fmla="*/ 53280 w 75960"/>
              <a:gd name="textAreaTop" fmla="*/ 2880 h 184320"/>
              <a:gd name="textAreaBottom" fmla="*/ 181440 h 1843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375"/>
                  <a:pt x="21600" y="750"/>
                </a:cubicBezTo>
                <a:lnTo>
                  <a:pt x="21600" y="20850"/>
                </a:lnTo>
                <a:cubicBezTo>
                  <a:pt x="21600" y="21225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Rectangle 7"/>
          <p:cNvSpPr/>
          <p:nvPr/>
        </p:nvSpPr>
        <p:spPr>
          <a:xfrm>
            <a:off x="3429000" y="8013600"/>
            <a:ext cx="762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NFk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Rectangle 173"/>
          <p:cNvSpPr/>
          <p:nvPr/>
        </p:nvSpPr>
        <p:spPr>
          <a:xfrm>
            <a:off x="4426920" y="8008920"/>
            <a:ext cx="1396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Signal transduction - NFk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Right Bracket 174"/>
          <p:cNvSpPr/>
          <p:nvPr/>
        </p:nvSpPr>
        <p:spPr>
          <a:xfrm>
            <a:off x="4191120" y="8024760"/>
            <a:ext cx="75960" cy="182520"/>
          </a:xfrm>
          <a:custGeom>
            <a:avLst/>
            <a:gdLst>
              <a:gd name="textAreaLeft" fmla="*/ 0 w 75960"/>
              <a:gd name="textAreaRight" fmla="*/ 53280 w 75960"/>
              <a:gd name="textAreaTop" fmla="*/ 2880 h 182520"/>
              <a:gd name="textAreaBottom" fmla="*/ 179640 h 1825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375"/>
                  <a:pt x="21600" y="750"/>
                </a:cubicBezTo>
                <a:lnTo>
                  <a:pt x="21600" y="20850"/>
                </a:lnTo>
                <a:cubicBezTo>
                  <a:pt x="21600" y="21225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Rectangle 69"/>
          <p:cNvSpPr/>
          <p:nvPr/>
        </p:nvSpPr>
        <p:spPr>
          <a:xfrm>
            <a:off x="3429000" y="6426360"/>
            <a:ext cx="762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27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</a:rPr>
              <a:t>kip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Rectangle 176"/>
          <p:cNvSpPr/>
          <p:nvPr/>
        </p:nvSpPr>
        <p:spPr>
          <a:xfrm>
            <a:off x="4419720" y="7481880"/>
            <a:ext cx="1600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Adhesion and Angiogenesi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Rectangle 7"/>
          <p:cNvSpPr/>
          <p:nvPr/>
        </p:nvSpPr>
        <p:spPr>
          <a:xfrm>
            <a:off x="4419720" y="7219800"/>
            <a:ext cx="1676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etastasi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TextBox 107"/>
          <p:cNvSpPr/>
          <p:nvPr/>
        </p:nvSpPr>
        <p:spPr>
          <a:xfrm>
            <a:off x="152280" y="544680"/>
            <a:ext cx="533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88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3-04T22:01:57Z</dcterms:created>
  <dc:creator>cshs</dc:creator>
  <dc:description/>
  <dc:language>en-US</dc:language>
  <cp:lastModifiedBy>shamantha</cp:lastModifiedBy>
  <dcterms:modified xsi:type="dcterms:W3CDTF">2011-12-03T16:36:16Z</dcterms:modified>
  <cp:revision>903</cp:revision>
  <dc:subject/>
  <dc:title>Slide 1</dc:title>
</cp:coreProperties>
</file>